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 varScale="1">
        <p:scale>
          <a:sx n="123" d="100"/>
          <a:sy n="123" d="100"/>
        </p:scale>
        <p:origin x="-12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5" cy="36004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IKBIO-NAS\01.WorkingGroups\AG_Neuhaus\Group\Sarah-H&#252;cker\6%20OLGs%20in%20Sakai\Kompetitives%20Wachstum\OLGECs51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7.1988407699037624E-2"/>
          <c:y val="5.1400554097404488E-2"/>
          <c:w val="0.9277906824146982"/>
          <c:h val="0.785001458151064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ew substances aerobic'!$BH$1</c:f>
              <c:strCache>
                <c:ptCount val="1"/>
                <c:pt idx="0">
                  <c:v>EHEC WT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new substances aerobic'!$BI$2:$BI$9</c:f>
                <c:numCache>
                  <c:formatCode>General</c:formatCode>
                  <c:ptCount val="8"/>
                  <c:pt idx="0">
                    <c:v>3.6104324282658076</c:v>
                  </c:pt>
                  <c:pt idx="1">
                    <c:v>1.7746313341990347</c:v>
                  </c:pt>
                  <c:pt idx="2">
                    <c:v>7.5802790851764943</c:v>
                  </c:pt>
                  <c:pt idx="3">
                    <c:v>0.8700477989275901</c:v>
                  </c:pt>
                  <c:pt idx="4">
                    <c:v>4.1471306154413305</c:v>
                  </c:pt>
                  <c:pt idx="5">
                    <c:v>2.5465993985341875</c:v>
                  </c:pt>
                  <c:pt idx="6">
                    <c:v>8.6506528642871316</c:v>
                  </c:pt>
                  <c:pt idx="7">
                    <c:v>4.9632477537224124</c:v>
                  </c:pt>
                </c:numCache>
              </c:numRef>
            </c:plus>
            <c:minus>
              <c:numRef>
                <c:f>'new substances aerobic'!$BI$2:$BI$9</c:f>
                <c:numCache>
                  <c:formatCode>General</c:formatCode>
                  <c:ptCount val="8"/>
                  <c:pt idx="0">
                    <c:v>3.6104324282658076</c:v>
                  </c:pt>
                  <c:pt idx="1">
                    <c:v>1.7746313341990347</c:v>
                  </c:pt>
                  <c:pt idx="2">
                    <c:v>7.5802790851764943</c:v>
                  </c:pt>
                  <c:pt idx="3">
                    <c:v>0.8700477989275901</c:v>
                  </c:pt>
                  <c:pt idx="4">
                    <c:v>4.1471306154413305</c:v>
                  </c:pt>
                  <c:pt idx="5">
                    <c:v>2.5465993985341875</c:v>
                  </c:pt>
                  <c:pt idx="6">
                    <c:v>8.6506528642871316</c:v>
                  </c:pt>
                  <c:pt idx="7">
                    <c:v>4.9632477537224124</c:v>
                  </c:pt>
                </c:numCache>
              </c:numRef>
            </c:minus>
          </c:errBars>
          <c:cat>
            <c:strRef>
              <c:f>'new substances aerobic'!$BG$2:$BG$9</c:f>
              <c:strCache>
                <c:ptCount val="8"/>
                <c:pt idx="0">
                  <c:v>0.5 LB pH 5</c:v>
                </c:pt>
                <c:pt idx="1">
                  <c:v>0.5 LB pH 8.2</c:v>
                </c:pt>
                <c:pt idx="2">
                  <c:v>0.5 LB + 400 mM NaCl</c:v>
                </c:pt>
                <c:pt idx="3">
                  <c:v>0.5 LB + 0.5 mM CuCl2</c:v>
                </c:pt>
                <c:pt idx="4">
                  <c:v>0.5 LB + 2 mM formic acid</c:v>
                </c:pt>
                <c:pt idx="5">
                  <c:v>0.5 LB + 2.5 mM malonic acid</c:v>
                </c:pt>
                <c:pt idx="6">
                  <c:v>0.5 LB + 400 µM ZnCl2</c:v>
                </c:pt>
                <c:pt idx="7">
                  <c:v>0.5 LB + 4 mM malic acid</c:v>
                </c:pt>
              </c:strCache>
            </c:strRef>
          </c:cat>
          <c:val>
            <c:numRef>
              <c:f>'new substances aerobic'!$BH$2:$BH$9</c:f>
              <c:numCache>
                <c:formatCode>General</c:formatCode>
                <c:ptCount val="8"/>
                <c:pt idx="0">
                  <c:v>49.516966347320817</c:v>
                </c:pt>
                <c:pt idx="1">
                  <c:v>50.184600342721694</c:v>
                </c:pt>
                <c:pt idx="2">
                  <c:v>55.886482228597963</c:v>
                </c:pt>
                <c:pt idx="3">
                  <c:v>50.162039054480054</c:v>
                </c:pt>
                <c:pt idx="4">
                  <c:v>51.811769102322614</c:v>
                </c:pt>
                <c:pt idx="5">
                  <c:v>50.32897295454891</c:v>
                </c:pt>
                <c:pt idx="6">
                  <c:v>53.38132877613711</c:v>
                </c:pt>
                <c:pt idx="7">
                  <c:v>53.618079688935929</c:v>
                </c:pt>
              </c:numCache>
            </c:numRef>
          </c:val>
        </c:ser>
        <c:ser>
          <c:idx val="1"/>
          <c:order val="1"/>
          <c:tx>
            <c:strRef>
              <c:f>'new substances aerobic'!$BJ$1</c:f>
              <c:strCache>
                <c:ptCount val="1"/>
                <c:pt idx="0">
                  <c:v>EHEC ∆laoB</c:v>
                </c:pt>
              </c:strCache>
            </c:strRef>
          </c:tx>
          <c:spPr>
            <a:solidFill>
              <a:schemeClr val="accent2"/>
            </a:solidFill>
            <a:ln w="15875" cap="rnd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ew substances aerobic'!$BK$2:$BK$9</c:f>
                <c:numCache>
                  <c:formatCode>General</c:formatCode>
                  <c:ptCount val="8"/>
                  <c:pt idx="0">
                    <c:v>3.6104324282658111</c:v>
                  </c:pt>
                  <c:pt idx="1">
                    <c:v>1.7746313341990405</c:v>
                  </c:pt>
                  <c:pt idx="2">
                    <c:v>7.5802790851764943</c:v>
                  </c:pt>
                  <c:pt idx="3">
                    <c:v>0.87004779892758799</c:v>
                  </c:pt>
                  <c:pt idx="4">
                    <c:v>4.1471306154413314</c:v>
                  </c:pt>
                  <c:pt idx="5">
                    <c:v>2.5465993985341928</c:v>
                  </c:pt>
                  <c:pt idx="6">
                    <c:v>8.6506528642871547</c:v>
                  </c:pt>
                  <c:pt idx="7">
                    <c:v>4.9632477537224053</c:v>
                  </c:pt>
                </c:numCache>
              </c:numRef>
            </c:plus>
            <c:minus>
              <c:numRef>
                <c:f>'new substances aerobic'!$BK$2:$BK$9</c:f>
                <c:numCache>
                  <c:formatCode>General</c:formatCode>
                  <c:ptCount val="8"/>
                  <c:pt idx="0">
                    <c:v>3.6104324282658111</c:v>
                  </c:pt>
                  <c:pt idx="1">
                    <c:v>1.7746313341990405</c:v>
                  </c:pt>
                  <c:pt idx="2">
                    <c:v>7.5802790851764943</c:v>
                  </c:pt>
                  <c:pt idx="3">
                    <c:v>0.87004779892758799</c:v>
                  </c:pt>
                  <c:pt idx="4">
                    <c:v>4.1471306154413314</c:v>
                  </c:pt>
                  <c:pt idx="5">
                    <c:v>2.5465993985341928</c:v>
                  </c:pt>
                  <c:pt idx="6">
                    <c:v>8.6506528642871547</c:v>
                  </c:pt>
                  <c:pt idx="7">
                    <c:v>4.9632477537224053</c:v>
                  </c:pt>
                </c:numCache>
              </c:numRef>
            </c:minus>
          </c:errBars>
          <c:cat>
            <c:strRef>
              <c:f>'new substances aerobic'!$BG$2:$BG$9</c:f>
              <c:strCache>
                <c:ptCount val="8"/>
                <c:pt idx="0">
                  <c:v>0.5 LB pH 5</c:v>
                </c:pt>
                <c:pt idx="1">
                  <c:v>0.5 LB pH 8.2</c:v>
                </c:pt>
                <c:pt idx="2">
                  <c:v>0.5 LB + 400 mM NaCl</c:v>
                </c:pt>
                <c:pt idx="3">
                  <c:v>0.5 LB + 0.5 mM CuCl2</c:v>
                </c:pt>
                <c:pt idx="4">
                  <c:v>0.5 LB + 2 mM formic acid</c:v>
                </c:pt>
                <c:pt idx="5">
                  <c:v>0.5 LB + 2.5 mM malonic acid</c:v>
                </c:pt>
                <c:pt idx="6">
                  <c:v>0.5 LB + 400 µM ZnCl2</c:v>
                </c:pt>
                <c:pt idx="7">
                  <c:v>0.5 LB + 4 mM malic acid</c:v>
                </c:pt>
              </c:strCache>
            </c:strRef>
          </c:cat>
          <c:val>
            <c:numRef>
              <c:f>'new substances aerobic'!$BJ$2:$BJ$9</c:f>
              <c:numCache>
                <c:formatCode>General</c:formatCode>
                <c:ptCount val="8"/>
                <c:pt idx="0">
                  <c:v>50.483033652679183</c:v>
                </c:pt>
                <c:pt idx="1">
                  <c:v>49.815399657278313</c:v>
                </c:pt>
                <c:pt idx="2">
                  <c:v>44.11351777140203</c:v>
                </c:pt>
                <c:pt idx="3">
                  <c:v>49.837960945519946</c:v>
                </c:pt>
                <c:pt idx="4">
                  <c:v>48.188230897677386</c:v>
                </c:pt>
                <c:pt idx="5">
                  <c:v>49.67102704545109</c:v>
                </c:pt>
                <c:pt idx="6">
                  <c:v>46.61867122386289</c:v>
                </c:pt>
                <c:pt idx="7">
                  <c:v>46.3819203110640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442048"/>
        <c:axId val="77386816"/>
      </c:barChart>
      <c:catAx>
        <c:axId val="374420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7386816"/>
        <c:crosses val="autoZero"/>
        <c:auto val="1"/>
        <c:lblAlgn val="ctr"/>
        <c:lblOffset val="100"/>
        <c:noMultiLvlLbl val="0"/>
      </c:catAx>
      <c:valAx>
        <c:axId val="773868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442048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6.3667979002624664E-2"/>
          <c:y val="4.5912438028579763E-2"/>
          <c:w val="0.20824300087489064"/>
          <c:h val="0.15799285505978419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9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247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528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561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274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845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801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900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07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337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946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53DEA-50D9-4507-9D44-7BA89B9AD070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290D2-3088-4D45-B754-01A82A7675C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571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/>
          <p:cNvGraphicFramePr>
            <a:graphicFrameLocks/>
          </p:cNvGraphicFramePr>
          <p:nvPr/>
        </p:nvGraphicFramePr>
        <p:xfrm>
          <a:off x="2286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9351062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Bildschirmpräsentation (4:3)</PresentationFormat>
  <Paragraphs>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rah</dc:creator>
  <cp:lastModifiedBy>Sarah</cp:lastModifiedBy>
  <cp:revision>1</cp:revision>
  <dcterms:created xsi:type="dcterms:W3CDTF">2017-06-19T13:53:12Z</dcterms:created>
  <dcterms:modified xsi:type="dcterms:W3CDTF">2017-06-19T13:54:18Z</dcterms:modified>
</cp:coreProperties>
</file>